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0ECBF-9008-4740-B8D6-8904F1A743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24F88-C120-452B-BBFC-28C4AF7693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F47D7-64CB-4327-81A7-82EE900B10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DF77E-63F3-4448-923F-AF43EF1108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1F48B-5663-4325-AC4B-EF2DBF85F6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3E1DF-913D-4FB4-A092-6A73B21B2B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440F6-FB98-497C-AA60-3FB08E378D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CD188-22EB-4441-AFAD-7A174204D5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6464D-6B89-4437-A62B-A82140C7C3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C2FDC-3C52-4600-930F-DD22D067C9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A1EFC-7379-4875-94D3-3E5F6ECAFD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DD17E-CBC2-434C-889C-46B7AE151D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68A548-B94D-479C-AB42-6025AE80282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6858000" cy="21097800"/>
        </p:xfrm>
        <a:graphic>
          <a:graphicData uri="http://schemas.openxmlformats.org/drawingml/2006/table">
            <a:tbl>
              <a:tblPr/>
              <a:tblGrid>
                <a:gridCol w="1865160"/>
                <a:gridCol w="1106640"/>
                <a:gridCol w="1033560"/>
                <a:gridCol w="1368360"/>
                <a:gridCol w="1484280"/>
              </a:tblGrid>
              <a:tr h="12142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ubject Spec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oma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CBI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xonomy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NCBI RefSeq Protei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CBI Genom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ject 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nabae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variabilis A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94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02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6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6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quifex aeolic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VF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43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23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dellovibri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ovor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D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44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5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6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lamyd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chomat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/HAR- 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152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8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lamyd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chomatis D/U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/C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25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halococcoid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thenogenes 1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31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inococc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adiodurans 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32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1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395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usobacteri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ucleatum subsp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ucleatum A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55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03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elicobac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epaticus A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14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52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elicobacter pylor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J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59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37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cobacteri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ubercul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DC15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33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1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26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cobacteri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ubercul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37R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33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9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onorrhoeae F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22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ningitidis MC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25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ningitidis Z24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25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37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icketts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wazekii str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drid 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29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phylococc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C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30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23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phylococc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subsp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Mu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88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phylococc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subsp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MW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66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phylococc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subsp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ureus NCTC 83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30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8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hermoto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ritima MSB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32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eponema denticola ATCC 354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32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abidopsis thalia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4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5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enorhabditis elega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2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ndida glabrata CBS 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5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1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yptococcus neoformans var. neoformans JEC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468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baryomyces hansenii CBS7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5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osophila melanogas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8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tamoeba histolytica HM-1:IM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43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emothecium gossyp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1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6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8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luyveromyces lactis NRRL Y-11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5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us muscul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87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yza sativ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1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hizosaccharomyces pomb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8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ypanosoma cruz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6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6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arrowia lipolytica CLIB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5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31T08:17:21Z</dcterms:created>
  <dc:creator>Simon Chan</dc:creator>
  <dc:description/>
  <dc:language>en-US</dc:language>
  <cp:lastModifiedBy>sichan</cp:lastModifiedBy>
  <dcterms:modified xsi:type="dcterms:W3CDTF">2007-06-13T18:01:43Z</dcterms:modified>
  <cp:revision>66</cp:revision>
  <dc:subject/>
  <dc:title>Slide 1</dc:title>
</cp:coreProperties>
</file>